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8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19381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2034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1475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30985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820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9135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7619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7447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1044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4733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22825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C824F-33E6-466C-AB2C-A560D67D22E0}" type="datetimeFigureOut">
              <a:rPr lang="en-CA" smtClean="0"/>
              <a:t>2021-07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37070-734F-4EAD-8FDC-4BC627F865C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6866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89632C7-97CA-4F82-8D99-EEFD37853C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4539919"/>
              </p:ext>
            </p:extLst>
          </p:nvPr>
        </p:nvGraphicFramePr>
        <p:xfrm>
          <a:off x="523876" y="768519"/>
          <a:ext cx="2419350" cy="2028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r:id="rId3" imgW="3503400" imgH="2938137" progId="Prism8.Document">
                  <p:embed/>
                </p:oleObj>
              </mc:Choice>
              <mc:Fallback>
                <p:oleObj r:id="rId3" imgW="3503400" imgH="2938137" progId="Prism8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3876" y="768519"/>
                        <a:ext cx="2419350" cy="20288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D4EABD3-7715-486E-A7CE-E0590529F2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8118376"/>
              </p:ext>
            </p:extLst>
          </p:nvPr>
        </p:nvGraphicFramePr>
        <p:xfrm>
          <a:off x="3381376" y="768519"/>
          <a:ext cx="2600325" cy="2152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5" imgW="3639171" imgH="2997562" progId="Prism8.Document">
                  <p:embed/>
                </p:oleObj>
              </mc:Choice>
              <mc:Fallback>
                <p:oleObj r:id="rId5" imgW="3639171" imgH="2997562" progId="Prism8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81376" y="768519"/>
                        <a:ext cx="2600325" cy="21526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9DA2F0A-B097-49A0-83EC-E3350BEE9C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3485788"/>
              </p:ext>
            </p:extLst>
          </p:nvPr>
        </p:nvGraphicFramePr>
        <p:xfrm>
          <a:off x="523876" y="3373606"/>
          <a:ext cx="2505075" cy="2095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r:id="rId7" imgW="3521767" imgH="2947141" progId="Prism8.Document">
                  <p:embed/>
                </p:oleObj>
              </mc:Choice>
              <mc:Fallback>
                <p:oleObj r:id="rId7" imgW="3521767" imgH="2947141" progId="Prism8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3876" y="3373606"/>
                        <a:ext cx="2505075" cy="20955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ED7AFAD1-46E6-492B-A7AE-E9CFA7A909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0523652"/>
              </p:ext>
            </p:extLst>
          </p:nvPr>
        </p:nvGraphicFramePr>
        <p:xfrm>
          <a:off x="3381376" y="3373606"/>
          <a:ext cx="2505075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9" imgW="3517085" imgH="2938137" progId="Prism8.Document">
                  <p:embed/>
                </p:oleObj>
              </mc:Choice>
              <mc:Fallback>
                <p:oleObj r:id="rId9" imgW="3517085" imgH="2938137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81376" y="3373606"/>
                        <a:ext cx="2505075" cy="20859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5">
            <a:extLst>
              <a:ext uri="{FF2B5EF4-FFF2-40B4-BE49-F238E27FC236}">
                <a16:creationId xmlns:a16="http://schemas.microsoft.com/office/drawing/2014/main" id="{A01368A8-552D-4958-92EE-A8D475B168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876" y="484272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)                                                                  (B)</a:t>
            </a:r>
            <a:endParaRPr kumimoji="0" lang="en-CA" altLang="en-US" sz="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C5248924-CFF8-44AB-902F-8C36D4D051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876" y="3059281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                                                                   (D)</a:t>
            </a:r>
            <a:endParaRPr kumimoji="0" lang="en-CA" altLang="en-US" sz="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F94D4449-D2BF-4088-87BE-6C55C8180C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876" y="5611981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8">
            <a:extLst>
              <a:ext uri="{FF2B5EF4-FFF2-40B4-BE49-F238E27FC236}">
                <a16:creationId xmlns:a16="http://schemas.microsoft.com/office/drawing/2014/main" id="{4531E3DB-2BFE-4FE8-937A-133C3B6ED0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876" y="5783431"/>
            <a:ext cx="6139543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l Fig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1: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irculating EV levels throughout pregnancy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Shown are EV levels from baseline (1</a:t>
            </a:r>
            <a:r>
              <a:rPr kumimoji="0" lang="en-US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t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rimester), 24 weeks (second trimester), and 34 weeks (3</a:t>
            </a:r>
            <a:r>
              <a:rPr kumimoji="0" lang="en-US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d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rimester). A total of 134 individuals had samples available from all 3 time points. No significant differences between time points were seen for p</a:t>
            </a:r>
            <a:r>
              <a:rPr kumimoji="0" lang="en-US" altLang="en-US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latelet-derived EVs (A, P=0.8237), endothelial-derived EV (B, P=0.4342), leukocyte-derived EVs (C, P=0.6491), or total </a:t>
            </a:r>
            <a:r>
              <a:rPr kumimoji="0" lang="en-US" altLang="en-US" sz="1200" b="0" i="0" u="none" strike="noStrike" cap="none" normalizeH="0" baseline="0" dirty="0" err="1" bmk="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nexin</a:t>
            </a:r>
            <a:r>
              <a:rPr kumimoji="0" lang="en-US" altLang="en-US" sz="1200" b="0" i="0" u="none" strike="noStrike" cap="none" normalizeH="0" baseline="0" bmk="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smtClean="0" bmk="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+ </a:t>
            </a:r>
            <a:r>
              <a:rPr kumimoji="0" lang="en-US" altLang="en-US" sz="1200" b="0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Vs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D, P=0.5819).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251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3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8.Documen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ylan Burger</dc:creator>
  <cp:lastModifiedBy>Dylan Burger</cp:lastModifiedBy>
  <cp:revision>2</cp:revision>
  <dcterms:created xsi:type="dcterms:W3CDTF">2021-03-17T15:26:30Z</dcterms:created>
  <dcterms:modified xsi:type="dcterms:W3CDTF">2021-07-19T16:51:58Z</dcterms:modified>
</cp:coreProperties>
</file>